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11.jpeg" ContentType="image/jpeg"/>
  <Override PartName="/ppt/media/image12.jpeg" ContentType="image/jpeg"/>
  <Override PartName="/ppt/media/image1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804A41-E4BB-485C-AED8-92B2236E37F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724055-4BAD-41D1-8315-D48109F796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A96445-F0D4-4B82-802D-65749AFECF5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BFFDF5-E7D9-48A2-908F-59B26EF70F2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4CABC7-6F5D-48FE-817D-20452B1156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99F928-F282-4255-BEDD-229FFD0C59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662DD4-7B6F-4FA4-9E99-F81B5C8CC7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21CAF1-0934-4080-8528-BE3EEF127F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C4CBBA-BAA8-446C-8928-24F45CBFC9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B1B189-3D64-4B6B-80A9-77EB2F8B5C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820CCE-AD9C-4C2C-8D2A-EFC9E39766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69449C-B27B-48C3-AC72-AC51A5B647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9FBDE15-793C-4DDB-9816-87F8A27A6A9A}" type="slidenum"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그룹 1"/>
          <p:cNvGrpSpPr/>
          <p:nvPr/>
        </p:nvGrpSpPr>
        <p:grpSpPr>
          <a:xfrm>
            <a:off x="253440" y="2852640"/>
            <a:ext cx="7776000" cy="2951280"/>
            <a:chOff x="253440" y="2852640"/>
            <a:chExt cx="7776000" cy="2951280"/>
          </a:xfrm>
        </p:grpSpPr>
        <p:grpSp>
          <p:nvGrpSpPr>
            <p:cNvPr id="42" name="그룹 63"/>
            <p:cNvGrpSpPr/>
            <p:nvPr/>
          </p:nvGrpSpPr>
          <p:grpSpPr>
            <a:xfrm>
              <a:off x="253440" y="2852640"/>
              <a:ext cx="6788160" cy="2951280"/>
              <a:chOff x="253440" y="2852640"/>
              <a:chExt cx="6788160" cy="2951280"/>
            </a:xfrm>
          </p:grpSpPr>
          <p:sp>
            <p:nvSpPr>
              <p:cNvPr id="43" name="Text Box 54"/>
              <p:cNvSpPr/>
              <p:nvPr/>
            </p:nvSpPr>
            <p:spPr>
              <a:xfrm>
                <a:off x="253440" y="2852640"/>
                <a:ext cx="3330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800" spc="-1" strike="noStrike">
                    <a:solidFill>
                      <a:srgbClr val="000000"/>
                    </a:solidFill>
                    <a:latin typeface="Arial"/>
                    <a:ea typeface="맑은 고딕"/>
                  </a:rPr>
                  <a:t>B</a:t>
                </a:r>
                <a:endParaRPr b="0" lang="en-US" sz="1800" spc="-1" strike="noStrike">
                  <a:solidFill>
                    <a:srgbClr val="000000"/>
                  </a:solidFill>
                  <a:latin typeface="굴림"/>
                </a:endParaRPr>
              </a:p>
            </p:txBody>
          </p:sp>
          <p:grpSp>
            <p:nvGrpSpPr>
              <p:cNvPr id="44" name="그룹 62"/>
              <p:cNvGrpSpPr/>
              <p:nvPr/>
            </p:nvGrpSpPr>
            <p:grpSpPr>
              <a:xfrm>
                <a:off x="484920" y="2923560"/>
                <a:ext cx="6556680" cy="2880360"/>
                <a:chOff x="484920" y="2923560"/>
                <a:chExt cx="6556680" cy="2880360"/>
              </a:xfrm>
            </p:grpSpPr>
            <p:grpSp>
              <p:nvGrpSpPr>
                <p:cNvPr id="45" name="그룹 61"/>
                <p:cNvGrpSpPr/>
                <p:nvPr/>
              </p:nvGrpSpPr>
              <p:grpSpPr>
                <a:xfrm>
                  <a:off x="484920" y="2923560"/>
                  <a:ext cx="6556680" cy="1405440"/>
                  <a:chOff x="484920" y="2923560"/>
                  <a:chExt cx="6556680" cy="1405440"/>
                </a:xfrm>
              </p:grpSpPr>
              <p:pic>
                <p:nvPicPr>
                  <p:cNvPr id="46" name="Picture 4" descr=""/>
                  <p:cNvPicPr/>
                  <p:nvPr/>
                </p:nvPicPr>
                <p:blipFill>
                  <a:blip r:embed="rId1"/>
                  <a:srcRect l="2528" t="4609" r="8848" b="1536"/>
                  <a:stretch/>
                </p:blipFill>
                <p:spPr>
                  <a:xfrm>
                    <a:off x="484920" y="2923560"/>
                    <a:ext cx="1333080" cy="1405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47" name="Picture 5" descr=""/>
                  <p:cNvPicPr/>
                  <p:nvPr/>
                </p:nvPicPr>
                <p:blipFill>
                  <a:blip r:embed="rId2"/>
                  <a:srcRect l="2528" t="4609" r="8848" b="1536"/>
                  <a:stretch/>
                </p:blipFill>
                <p:spPr>
                  <a:xfrm>
                    <a:off x="1790640" y="2923560"/>
                    <a:ext cx="1333080" cy="1405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48" name="Picture 6" descr=""/>
                  <p:cNvPicPr/>
                  <p:nvPr/>
                </p:nvPicPr>
                <p:blipFill>
                  <a:blip r:embed="rId3"/>
                  <a:srcRect l="2528" t="4609" r="8848" b="1536"/>
                  <a:stretch/>
                </p:blipFill>
                <p:spPr>
                  <a:xfrm>
                    <a:off x="3096360" y="2923560"/>
                    <a:ext cx="1333080" cy="1405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49" name="Picture 2" descr=""/>
                  <p:cNvPicPr/>
                  <p:nvPr/>
                </p:nvPicPr>
                <p:blipFill>
                  <a:blip r:embed="rId4"/>
                  <a:srcRect l="0" t="4271" r="9872" b="1536"/>
                  <a:stretch/>
                </p:blipFill>
                <p:spPr>
                  <a:xfrm>
                    <a:off x="4402440" y="2923560"/>
                    <a:ext cx="1333440" cy="1405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50" name="Picture 3" descr=""/>
                  <p:cNvPicPr/>
                  <p:nvPr/>
                </p:nvPicPr>
                <p:blipFill>
                  <a:blip r:embed="rId5"/>
                  <a:srcRect l="0" t="1214" r="11044" b="1536"/>
                  <a:stretch/>
                </p:blipFill>
                <p:spPr>
                  <a:xfrm>
                    <a:off x="5708160" y="2923560"/>
                    <a:ext cx="1333440" cy="1405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grpSp>
            <p:grpSp>
              <p:nvGrpSpPr>
                <p:cNvPr id="51" name="그룹 60"/>
                <p:cNvGrpSpPr/>
                <p:nvPr/>
              </p:nvGrpSpPr>
              <p:grpSpPr>
                <a:xfrm>
                  <a:off x="484920" y="4398480"/>
                  <a:ext cx="6556680" cy="1405440"/>
                  <a:chOff x="484920" y="4398480"/>
                  <a:chExt cx="6556680" cy="1405440"/>
                </a:xfrm>
              </p:grpSpPr>
              <p:pic>
                <p:nvPicPr>
                  <p:cNvPr id="52" name="Picture 7" descr=""/>
                  <p:cNvPicPr/>
                  <p:nvPr/>
                </p:nvPicPr>
                <p:blipFill>
                  <a:blip r:embed="rId6"/>
                  <a:srcRect l="2462" t="4609" r="8618" b="1536"/>
                  <a:stretch/>
                </p:blipFill>
                <p:spPr>
                  <a:xfrm>
                    <a:off x="484920" y="4398480"/>
                    <a:ext cx="1333080" cy="1405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53" name="Picture 8" descr=""/>
                  <p:cNvPicPr/>
                  <p:nvPr/>
                </p:nvPicPr>
                <p:blipFill>
                  <a:blip r:embed="rId7"/>
                  <a:srcRect l="2462" t="4609" r="8618" b="1536"/>
                  <a:stretch/>
                </p:blipFill>
                <p:spPr>
                  <a:xfrm>
                    <a:off x="1790640" y="4398480"/>
                    <a:ext cx="1333080" cy="1405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54" name="Picture 9" descr=""/>
                  <p:cNvPicPr/>
                  <p:nvPr/>
                </p:nvPicPr>
                <p:blipFill>
                  <a:blip r:embed="rId8"/>
                  <a:srcRect l="2462" t="4609" r="8618" b="1536"/>
                  <a:stretch/>
                </p:blipFill>
                <p:spPr>
                  <a:xfrm>
                    <a:off x="3096360" y="4398480"/>
                    <a:ext cx="1333080" cy="1405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55" name="Picture 5" descr=""/>
                  <p:cNvPicPr/>
                  <p:nvPr/>
                </p:nvPicPr>
                <p:blipFill>
                  <a:blip r:embed="rId9"/>
                  <a:srcRect l="0" t="0" r="9872" b="1536"/>
                  <a:stretch/>
                </p:blipFill>
                <p:spPr>
                  <a:xfrm>
                    <a:off x="4402440" y="4398480"/>
                    <a:ext cx="1333440" cy="1405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56" name="Picture 6" descr=""/>
                  <p:cNvPicPr/>
                  <p:nvPr/>
                </p:nvPicPr>
                <p:blipFill>
                  <a:blip r:embed="rId10"/>
                  <a:srcRect l="0" t="0" r="11044" b="1536"/>
                  <a:stretch/>
                </p:blipFill>
                <p:spPr>
                  <a:xfrm>
                    <a:off x="5708160" y="4398480"/>
                    <a:ext cx="1333440" cy="1405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grpSp>
          </p:grpSp>
        </p:grpSp>
        <p:sp>
          <p:nvSpPr>
            <p:cNvPr id="57" name="Text Box 58"/>
            <p:cNvSpPr/>
            <p:nvPr/>
          </p:nvSpPr>
          <p:spPr>
            <a:xfrm>
              <a:off x="7308720" y="3500640"/>
              <a:ext cx="720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BALF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8" name="Text Box 59"/>
            <p:cNvSpPr/>
            <p:nvPr/>
          </p:nvSpPr>
          <p:spPr>
            <a:xfrm>
              <a:off x="7382160" y="4869000"/>
              <a:ext cx="525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LLN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grpSp>
        <p:nvGrpSpPr>
          <p:cNvPr id="59" name="Group 56"/>
          <p:cNvGrpSpPr/>
          <p:nvPr/>
        </p:nvGrpSpPr>
        <p:grpSpPr>
          <a:xfrm>
            <a:off x="326520" y="115920"/>
            <a:ext cx="3237120" cy="2664720"/>
            <a:chOff x="326520" y="115920"/>
            <a:chExt cx="3237120" cy="2664720"/>
          </a:xfrm>
        </p:grpSpPr>
        <p:pic>
          <p:nvPicPr>
            <p:cNvPr id="60" name="그림 30" descr="DSC01502.JPG"/>
            <p:cNvPicPr/>
            <p:nvPr/>
          </p:nvPicPr>
          <p:blipFill>
            <a:blip r:embed="rId11">
              <a:lum contrast="10000"/>
            </a:blip>
            <a:srcRect l="23925" t="25881" r="39360" b="21633"/>
            <a:stretch/>
          </p:blipFill>
          <p:spPr>
            <a:xfrm rot="10800000">
              <a:off x="925200" y="1488600"/>
              <a:ext cx="1280520" cy="1292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1" name="그림 14" descr="DSC01481.JPG"/>
            <p:cNvPicPr/>
            <p:nvPr/>
          </p:nvPicPr>
          <p:blipFill>
            <a:blip r:embed="rId12">
              <a:lum contrast="10000"/>
            </a:blip>
            <a:srcRect l="19091" t="20101" r="35460" b="30724"/>
            <a:stretch/>
          </p:blipFill>
          <p:spPr>
            <a:xfrm rot="10800000">
              <a:off x="925200" y="146880"/>
              <a:ext cx="1280520" cy="1292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그림 17" descr="DSC01049.JPG"/>
            <p:cNvPicPr/>
            <p:nvPr/>
          </p:nvPicPr>
          <p:blipFill>
            <a:blip r:embed="rId13"/>
            <a:srcRect l="23469" t="17708" r="22962" b="20314"/>
            <a:stretch/>
          </p:blipFill>
          <p:spPr>
            <a:xfrm rot="16200000">
              <a:off x="2277360" y="1494360"/>
              <a:ext cx="1292040" cy="1280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3" name="직선 연결선 23"/>
            <p:cNvSpPr/>
            <p:nvPr/>
          </p:nvSpPr>
          <p:spPr>
            <a:xfrm>
              <a:off x="1896480" y="219240"/>
              <a:ext cx="245880" cy="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pic>
          <p:nvPicPr>
            <p:cNvPr id="64" name="그림 15" descr="P1.JPG"/>
            <p:cNvPicPr/>
            <p:nvPr/>
          </p:nvPicPr>
          <p:blipFill>
            <a:blip r:embed="rId14"/>
            <a:srcRect l="22402" t="28302" r="26988" b="17346"/>
            <a:stretch/>
          </p:blipFill>
          <p:spPr>
            <a:xfrm rot="10800000">
              <a:off x="2282760" y="147240"/>
              <a:ext cx="1280520" cy="1294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5" name="Text Box 8"/>
            <p:cNvSpPr/>
            <p:nvPr/>
          </p:nvSpPr>
          <p:spPr>
            <a:xfrm>
              <a:off x="920520" y="11592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Arial"/>
                  <a:ea typeface="맑은 고딕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66" name="Text Box 8"/>
            <p:cNvSpPr/>
            <p:nvPr/>
          </p:nvSpPr>
          <p:spPr>
            <a:xfrm>
              <a:off x="2268360" y="115920"/>
              <a:ext cx="27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Arial"/>
                  <a:ea typeface="맑은 고딕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67" name="Text Box 8"/>
            <p:cNvSpPr/>
            <p:nvPr/>
          </p:nvSpPr>
          <p:spPr>
            <a:xfrm>
              <a:off x="2252880" y="1459800"/>
              <a:ext cx="27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Arial"/>
                  <a:ea typeface="맑은 고딕"/>
                </a:rPr>
                <a:t>d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68" name="Text Box 8"/>
            <p:cNvSpPr/>
            <p:nvPr/>
          </p:nvSpPr>
          <p:spPr>
            <a:xfrm>
              <a:off x="920520" y="145980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Arial"/>
                  <a:ea typeface="맑은 고딕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69" name="Text Box 53"/>
            <p:cNvSpPr/>
            <p:nvPr/>
          </p:nvSpPr>
          <p:spPr>
            <a:xfrm>
              <a:off x="326520" y="115920"/>
              <a:ext cx="3330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맑은 고딕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0" name="직선 연결선 10"/>
            <p:cNvSpPr/>
            <p:nvPr/>
          </p:nvSpPr>
          <p:spPr>
            <a:xfrm>
              <a:off x="3256200" y="226080"/>
              <a:ext cx="245880" cy="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1" name="직선 연결선 10"/>
            <p:cNvSpPr/>
            <p:nvPr/>
          </p:nvSpPr>
          <p:spPr>
            <a:xfrm>
              <a:off x="1883520" y="1569960"/>
              <a:ext cx="245520" cy="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72" name="직선 연결선 10"/>
            <p:cNvSpPr/>
            <p:nvPr/>
          </p:nvSpPr>
          <p:spPr>
            <a:xfrm>
              <a:off x="3238560" y="1545120"/>
              <a:ext cx="245880" cy="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sp>
        <p:nvSpPr>
          <p:cNvPr id="73" name="Text Box 39"/>
          <p:cNvSpPr/>
          <p:nvPr/>
        </p:nvSpPr>
        <p:spPr>
          <a:xfrm>
            <a:off x="0" y="5950080"/>
            <a:ext cx="91440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Figure S1.</a:t>
            </a:r>
            <a:r>
              <a:rPr b="1" lang="en-US" sz="1200" spc="-1" strike="noStrike">
                <a:solidFill>
                  <a:srgbClr val="000000"/>
                </a:solidFill>
                <a:latin typeface="맑은 고딕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High-dose </a:t>
            </a:r>
            <a:r>
              <a:rPr b="1" i="1" lang="en-US" sz="12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Acanthamoeba</a:t>
            </a:r>
            <a:r>
              <a:rPr b="1" lang="en-US" sz="12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 trophozoite infection induces severe allergic airway inflammation.</a:t>
            </a:r>
            <a:r>
              <a:rPr b="0" lang="en-US" sz="12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 (A) Tissue inflammation observed on stained lung sections (a and c: PBS-treated; b and d: </a:t>
            </a:r>
            <a:r>
              <a:rPr b="0" i="1" lang="en-US" sz="12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Acanthamoeba</a:t>
            </a:r>
            <a:r>
              <a:rPr b="0" lang="en-US" sz="12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-infected; a and b, H&amp;E-stained; c and d, PAS-stained). (B) Cytokine concentrations in BALF and in the culture medium of CD3-stimulated lymphocytes isolated from LLNs were measured. (*</a:t>
            </a:r>
            <a:r>
              <a:rPr b="0" i="1" lang="en-US" sz="12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 &lt; 0.05, ** &lt; 0.01, ***</a:t>
            </a:r>
            <a:r>
              <a:rPr b="0" i="1" lang="en-US" sz="12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맑은 고딕"/>
                <a:ea typeface="맑은 고딕"/>
              </a:rPr>
              <a:t> &lt; 0.001).</a:t>
            </a:r>
            <a:endParaRPr b="0" lang="en-US" sz="12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1-28T05:59:20Z</dcterms:created>
  <dc:creator>Yu Hak Sun</dc:creator>
  <dc:description/>
  <dc:language>en-US</dc:language>
  <cp:lastModifiedBy>Yu Hak Sun</cp:lastModifiedBy>
  <dcterms:modified xsi:type="dcterms:W3CDTF">2014-02-28T00:47:46Z</dcterms:modified>
  <cp:revision>20</cp:revision>
  <dc:subject/>
  <dc:title>슬라이드 1</dc:title>
</cp:coreProperties>
</file>